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8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9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787984-5F62-7225-A1D9-E9D9647DDC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F76E9C-B0F1-A961-9D80-A2A04958E7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4A6043-472B-D65A-1517-29A7CF852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208275-171F-0B16-B9DE-4D6913562A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F08667-4702-3DB5-78AE-E1569750B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7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3BED8-4405-B86C-816C-5747678F05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A9A768-1BBC-4D23-E56C-AC1701FDC0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9770BD-1B7C-F6B1-BC55-E7894C9EF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423A29-9D62-CB2D-8CAF-8DD8264A3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74503D-6ED6-BD96-538E-6CC4074A04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926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F18149-4FB6-24B0-7941-6DB11347A4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E354AA3-8FA9-B4D3-02E6-E1B38D2951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B8C215-5E21-50DF-4F57-D776944D9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69B3D7-5803-E428-1F61-37D4C8AB39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F80568-27A6-39F4-1F80-674952E2E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991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BEE79F-28F1-3DCE-BA51-DF0C55C5FA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A6DA2E-7D25-0EDD-9CAA-8496A0DBA1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66AFFB-D80B-0A46-9BD1-501CB8327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5038A9-F8BE-614A-73A1-6C38AAB0E6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DB80B9-C17D-F9F7-4B44-8803F6C4A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707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5C291-87C5-697F-FFCE-9DDBAE718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8B52A3-6882-4CFC-AE2B-0D071F5D3B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BE263A-94AF-D836-BBDE-8B4616EB5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65B5E5-0C5B-7E4E-432E-7986EDD92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E1F511-0845-E666-6E43-9A56AA5EE8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346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60FF5E-E6A3-D877-F215-7831256445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069701-F9A2-B80B-25A3-9F855B3C41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0AC7DA-5915-E8E5-2E56-9F4A59E64A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423F3B-B06E-EBCA-F5CD-82954801F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96ADC5-0167-B08A-DFC6-EDB8CB58A9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612AB9-2C1D-FAB8-C78D-0B4BBD70E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700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13051F-00D2-DF50-7297-F507CB548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0B7F95-104C-5EF1-5CDC-28641956D1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FB51BBE-DFFD-A494-C319-B1B5939587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B2287C-6B87-C202-A182-CCEAD94E46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E7974C-0519-72D6-3BDB-D8AC6870E1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B55C6D-D374-F89F-3CDD-EF7CE2C00A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AE41E5-8DB0-3D1A-4F7A-1DA4D3240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2DCADD-4D6E-DF64-F6B5-B67C100DAF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558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FD6505-ACC7-BF16-7ED8-F5D4FE2D0B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3F11971-AE85-BDF6-297D-02E04F5F4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15DEEF8-08C3-22C2-8C45-C7A7AC22B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9687E0-F32A-AD42-EBA1-F06DF8FA1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644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3D7124-BB86-D9F1-3888-9C0BCEBFCF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C1E9AF3-FB1A-38E3-1CFE-7524689A7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B5FFC15-A59A-6EC5-C8F3-58B44B3F4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212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5162C8-BFE5-FE0E-917B-ACDF973511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2B19B5-E22B-BF17-663E-8EDD3135F0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88D2BD-4E39-577D-DEC3-E0FA5A0D3A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9D53CF-A5BC-2BA6-BC20-9BD8BF7A0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F33731-55B3-D345-9043-F4768D8EB5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F2335C-8006-DDD1-9ED7-D1E04DD07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775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2707F0-8149-3D81-0285-5C0C4D9EDF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0C79C2C-9A70-1529-879E-43E64C7F429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B4AC7D8-ACAE-4F6B-5C8D-66F145AC2C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44A0F7-E060-5ABA-34CA-601918353A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CA8AA0-41AA-11ED-3F0A-FFBAF0340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216FE8-F58F-ABF8-169C-CFEED2D8DD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733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E22959F-B0F5-C1DF-4360-874CDFBD0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55C870-D613-7EDF-A875-154EA27284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330587-2585-0B21-4B88-057C3957AA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2268FBC-0E2C-45F7-953F-ECC54F9A0ADE}" type="datetimeFigureOut">
              <a:rPr lang="en-US" smtClean="0"/>
              <a:t>2/26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A454F8-B830-8F6B-8FF7-04B0ADE07B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A859DB-F7BD-3A8D-65D8-2B4C4C7866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F28664-F984-4A19-A18C-3EAB3B5261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517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CBCDD969-BA30-E795-2F24-BC5FE093D891}"/>
              </a:ext>
            </a:extLst>
          </p:cNvPr>
          <p:cNvGraphicFramePr>
            <a:graphicFrameLocks noGrp="1"/>
          </p:cNvGraphicFramePr>
          <p:nvPr/>
        </p:nvGraphicFramePr>
        <p:xfrm>
          <a:off x="3235990" y="2155870"/>
          <a:ext cx="5497830" cy="2215769"/>
        </p:xfrm>
        <a:graphic>
          <a:graphicData uri="http://schemas.openxmlformats.org/drawingml/2006/table">
            <a:tbl>
              <a:tblPr firstRow="1" firstCol="1" bandRow="1"/>
              <a:tblGrid>
                <a:gridCol w="1139825">
                  <a:extLst>
                    <a:ext uri="{9D8B030D-6E8A-4147-A177-3AD203B41FA5}">
                      <a16:colId xmlns:a16="http://schemas.microsoft.com/office/drawing/2014/main" val="2191650214"/>
                    </a:ext>
                  </a:extLst>
                </a:gridCol>
                <a:gridCol w="2014855">
                  <a:extLst>
                    <a:ext uri="{9D8B030D-6E8A-4147-A177-3AD203B41FA5}">
                      <a16:colId xmlns:a16="http://schemas.microsoft.com/office/drawing/2014/main" val="2261530958"/>
                    </a:ext>
                  </a:extLst>
                </a:gridCol>
                <a:gridCol w="2343150">
                  <a:extLst>
                    <a:ext uri="{9D8B030D-6E8A-4147-A177-3AD203B41FA5}">
                      <a16:colId xmlns:a16="http://schemas.microsoft.com/office/drawing/2014/main" val="416237483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i="1" kern="0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Gene</a:t>
                      </a:r>
                      <a:endParaRPr lang="en-US" sz="12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kern="0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Forward primer (5’-&gt; 3’)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b="1" kern="0">
                          <a:solidFill>
                            <a:srgbClr val="FFFFFF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Reverse primer (5’-&gt; 3’)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95042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Full length IL1A</a:t>
                      </a:r>
                      <a:endParaRPr lang="en-US" sz="12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CGTGAGTTTCCCAGAAGAA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CTGCCCAAGATGAAGACCA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81105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N-terminal IL1A</a:t>
                      </a:r>
                      <a:endParaRPr lang="en-US" sz="12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CTGAGGGACAGCAGAACTA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TTCCCTCCCATGAGAAGCC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875344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-terminal IL1A</a:t>
                      </a:r>
                      <a:endParaRPr lang="en-US" sz="12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GACCAACCAGTGCTGCTGA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TGCCAAGCACACCCAGTAGT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9399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IL1B</a:t>
                      </a:r>
                      <a:endParaRPr lang="en-US" sz="12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AGCCCTTGCTGTAGTGGTG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GAAGCTGATGGCCCTAAACA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53914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IL6</a:t>
                      </a:r>
                      <a:endParaRPr lang="en-US" sz="12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AGGAGCCCAGCTATGAACT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GCAGGCAACACCAGGAG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62558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IL8</a:t>
                      </a:r>
                      <a:endParaRPr lang="en-US" sz="12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AATTTGGGGTGGAAAGGTT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TCCTGATTTCTGCAGCTCTGT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190625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IL1R1</a:t>
                      </a:r>
                      <a:endParaRPr lang="en-US" sz="12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TTGGGTTAAGAGGACAGGGA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TGATTTCTTCTCTGGAGGCTG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29602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IL1RN</a:t>
                      </a:r>
                      <a:endParaRPr lang="en-US" sz="1200" i="1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GCTTGCATCTTGCTGGATTT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solidFill>
                            <a:srgbClr val="000000"/>
                          </a:solidFill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CTCAGAAGACCTCCTGTCCT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61631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IL1RAP</a:t>
                      </a:r>
                      <a:endParaRPr lang="en-US" sz="12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TTAAAGGGAGGGGCAAGAG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CTCTCAGGTTCCCAAGAAA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5435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NOS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CGCTACAACATCCTGGAG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200" kern="10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ACATTCTGCTTCTGGAAACTA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98375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i="1" kern="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Vrinda" panose="020B0502040204020203" pitchFamily="34" charset="0"/>
                        </a:rPr>
                        <a:t>GAPDH</a:t>
                      </a:r>
                      <a:endParaRPr lang="en-US" sz="1200" i="1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ATGAAGGGGTCATTGATGG</a:t>
                      </a:r>
                      <a:endParaRPr lang="en-US" sz="1200" kern="10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100" kern="0" dirty="0">
                          <a:effectLst/>
                          <a:latin typeface="Aptos" panose="020B0004020202020204" pitchFamily="34" charset="0"/>
                          <a:ea typeface="Aptos" panose="020B0004020202020204" pitchFamily="34" charset="0"/>
                          <a:cs typeface="Times New Roman" panose="02020603050405020304" pitchFamily="18" charset="0"/>
                        </a:rPr>
                        <a:t>AAGGTGAAGGTCGGAGTCAA</a:t>
                      </a:r>
                      <a:endParaRPr lang="en-US" sz="1200" kern="100" dirty="0">
                        <a:effectLst/>
                        <a:latin typeface="Aptos" panose="020B0004020202020204" pitchFamily="34" charset="0"/>
                        <a:ea typeface="Aptos" panose="020B0004020202020204" pitchFamily="34" charset="0"/>
                        <a:cs typeface="Vrinda" panose="020B0502040204020203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8219699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5AE68C4-ED14-283F-172B-D6438C123736}"/>
              </a:ext>
            </a:extLst>
          </p:cNvPr>
          <p:cNvSpPr txBox="1"/>
          <p:nvPr/>
        </p:nvSpPr>
        <p:spPr>
          <a:xfrm>
            <a:off x="4443813" y="1878871"/>
            <a:ext cx="2732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Table 1: PCR Primers</a:t>
            </a:r>
          </a:p>
        </p:txBody>
      </p:sp>
    </p:spTree>
    <p:extLst>
      <p:ext uri="{BB962C8B-B14F-4D97-AF65-F5344CB8AC3E}">
        <p14:creationId xmlns:p14="http://schemas.microsoft.com/office/powerpoint/2010/main" val="3128614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urnett, Andrean L</dc:creator>
  <cp:lastModifiedBy>Burnett, Andrean L</cp:lastModifiedBy>
  <cp:revision>1</cp:revision>
  <dcterms:created xsi:type="dcterms:W3CDTF">2026-02-26T15:58:20Z</dcterms:created>
  <dcterms:modified xsi:type="dcterms:W3CDTF">2026-02-26T15:58:51Z</dcterms:modified>
</cp:coreProperties>
</file>